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7B899-BE57-4E61-8998-F204A0942D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A1C01-6368-4307-B342-1963D845A3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FDAE5-4A09-4DCC-A0D8-FFF5ECCFE6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DB5BA-C96A-4EF7-8C27-6C389561AF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F7C4F4-DE52-47A4-AB59-80278F385C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EE483-5F8A-4BA6-BE2F-08B204827D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DE581-E508-4F97-8AD1-29B6D40F9C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49193-A08B-4C4E-B6EB-28E2E69A8B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8DF8A-8533-42E2-967A-9E8A8366C5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5A4FF-82E4-4D78-A935-17C32E9CE9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112FC-7B8B-4BAB-81DB-156A7A7777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9E0B7-4276-4032-94D5-81AC6E8E50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E4305C-0E8E-4314-8206-287271BA1875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. Gating strategy to identify T-Lymphocytes (CD45+CD3+ cells).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From the total SVF cells present (a), the CD45+Low-SSC population was identified (b) and Lymphocytes (CD45+CD3+ cells) selected (c) for further analysis of CD4+ and CD8+ Lymphocytes (d) and their respective activation (e)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C:\Users\rlt24\AppData\Local\Temp\plot 5.PNG"/>
          <p:cNvPicPr/>
          <p:nvPr/>
        </p:nvPicPr>
        <p:blipFill>
          <a:blip r:embed="rId1"/>
          <a:stretch/>
        </p:blipFill>
        <p:spPr>
          <a:xfrm>
            <a:off x="4838760" y="6004080"/>
            <a:ext cx="2046240" cy="2016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C:\Users\rlt24\AppData\Local\Temp\plot 1.PNG"/>
          <p:cNvPicPr/>
          <p:nvPr/>
        </p:nvPicPr>
        <p:blipFill>
          <a:blip r:embed="rId2"/>
          <a:stretch/>
        </p:blipFill>
        <p:spPr>
          <a:xfrm>
            <a:off x="620640" y="2670120"/>
            <a:ext cx="2683080" cy="2716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" descr="C:\Users\rlt24\AppData\Local\Temp\plot 2.PNG"/>
          <p:cNvPicPr/>
          <p:nvPr/>
        </p:nvPicPr>
        <p:blipFill>
          <a:blip r:embed="rId3"/>
          <a:stretch/>
        </p:blipFill>
        <p:spPr>
          <a:xfrm>
            <a:off x="3573360" y="2670120"/>
            <a:ext cx="2664000" cy="2772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5" descr="C:\Users\rlt24\AppData\Local\Temp\plot 3.PNG"/>
          <p:cNvPicPr/>
          <p:nvPr/>
        </p:nvPicPr>
        <p:blipFill>
          <a:blip r:embed="rId4"/>
          <a:stretch/>
        </p:blipFill>
        <p:spPr>
          <a:xfrm>
            <a:off x="220680" y="5830920"/>
            <a:ext cx="2128680" cy="21686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6" descr="C:\Users\rlt24\AppData\Local\Temp\plot 4.PNG"/>
          <p:cNvPicPr/>
          <p:nvPr/>
        </p:nvPicPr>
        <p:blipFill>
          <a:blip r:embed="rId5"/>
          <a:stretch/>
        </p:blipFill>
        <p:spPr>
          <a:xfrm>
            <a:off x="2390760" y="5830920"/>
            <a:ext cx="2309760" cy="2219400"/>
          </a:xfrm>
          <a:prstGeom prst="rect">
            <a:avLst/>
          </a:prstGeom>
          <a:ln w="0">
            <a:noFill/>
          </a:ln>
        </p:spPr>
      </p:pic>
      <p:sp>
        <p:nvSpPr>
          <p:cNvPr id="47" name="TextBox 3"/>
          <p:cNvSpPr/>
          <p:nvPr/>
        </p:nvSpPr>
        <p:spPr>
          <a:xfrm rot="16200000">
            <a:off x="376560" y="3813840"/>
            <a:ext cx="576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SC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9"/>
          <p:cNvSpPr/>
          <p:nvPr/>
        </p:nvSpPr>
        <p:spPr>
          <a:xfrm rot="16200000">
            <a:off x="3313440" y="3813840"/>
            <a:ext cx="576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SC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1674720" y="5203800"/>
            <a:ext cx="576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4518000" y="5226120"/>
            <a:ext cx="927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45-V500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917640" y="7905600"/>
            <a:ext cx="927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3-V450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3"/>
          <p:cNvSpPr/>
          <p:nvPr/>
        </p:nvSpPr>
        <p:spPr>
          <a:xfrm>
            <a:off x="3191040" y="7905600"/>
            <a:ext cx="9284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4-FITC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4"/>
          <p:cNvSpPr/>
          <p:nvPr/>
        </p:nvSpPr>
        <p:spPr>
          <a:xfrm rot="16200000">
            <a:off x="1991880" y="6785280"/>
            <a:ext cx="100008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8-PE-Cy7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5"/>
          <p:cNvSpPr/>
          <p:nvPr/>
        </p:nvSpPr>
        <p:spPr>
          <a:xfrm rot="16200000">
            <a:off x="-257760" y="6781320"/>
            <a:ext cx="100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45-V500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6"/>
          <p:cNvSpPr/>
          <p:nvPr/>
        </p:nvSpPr>
        <p:spPr>
          <a:xfrm>
            <a:off x="5424480" y="7905600"/>
            <a:ext cx="927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69-APC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7"/>
          <p:cNvSpPr/>
          <p:nvPr/>
        </p:nvSpPr>
        <p:spPr>
          <a:xfrm rot="16200000">
            <a:off x="4271040" y="6832080"/>
            <a:ext cx="11952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25-APC-Cy7-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5516640" y="4687920"/>
            <a:ext cx="93672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600" spc="-1" strike="noStrike">
                <a:solidFill>
                  <a:srgbClr val="000000"/>
                </a:solidFill>
                <a:latin typeface="Arial"/>
                <a:ea typeface="Arial"/>
              </a:rPr>
              <a:t>CD45+ Low SSC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1133640" y="6105600"/>
            <a:ext cx="92700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600" spc="-1" strike="noStrike">
                <a:solidFill>
                  <a:srgbClr val="000000"/>
                </a:solidFill>
                <a:latin typeface="Arial"/>
                <a:ea typeface="Arial"/>
              </a:rPr>
              <a:t>Lymphocyte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2832120" y="6032520"/>
            <a:ext cx="92700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600" spc="-1" strike="noStrike">
                <a:solidFill>
                  <a:srgbClr val="000000"/>
                </a:solidFill>
                <a:latin typeface="Arial"/>
                <a:ea typeface="Arial"/>
              </a:rPr>
              <a:t>CD8+ Lymphocyte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3398760" y="6927840"/>
            <a:ext cx="92700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600" spc="-1" strike="noStrike">
                <a:solidFill>
                  <a:srgbClr val="000000"/>
                </a:solidFill>
                <a:latin typeface="Arial"/>
                <a:ea typeface="Arial"/>
              </a:rPr>
              <a:t>CD4+ Lymphocyte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3"/>
          <p:cNvSpPr/>
          <p:nvPr/>
        </p:nvSpPr>
        <p:spPr>
          <a:xfrm>
            <a:off x="5054760" y="6537240"/>
            <a:ext cx="431640" cy="169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CD25+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5415120" y="6440400"/>
            <a:ext cx="431640" cy="169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CD69+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765000" y="5873760"/>
            <a:ext cx="12798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45+ LOW SS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3038400" y="5816520"/>
            <a:ext cx="127944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LYMPHOCYT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5199120" y="5807160"/>
            <a:ext cx="127944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CD4+ LYMPHOCYTE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"/>
          <p:cNvSpPr/>
          <p:nvPr/>
        </p:nvSpPr>
        <p:spPr>
          <a:xfrm>
            <a:off x="350280" y="2598840"/>
            <a:ext cx="33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8"/>
          <p:cNvSpPr/>
          <p:nvPr/>
        </p:nvSpPr>
        <p:spPr>
          <a:xfrm>
            <a:off x="3360240" y="2598840"/>
            <a:ext cx="348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9"/>
          <p:cNvSpPr/>
          <p:nvPr/>
        </p:nvSpPr>
        <p:spPr>
          <a:xfrm>
            <a:off x="-23760" y="58165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0"/>
          <p:cNvSpPr/>
          <p:nvPr/>
        </p:nvSpPr>
        <p:spPr>
          <a:xfrm>
            <a:off x="2275920" y="5816520"/>
            <a:ext cx="348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1"/>
          <p:cNvSpPr/>
          <p:nvPr/>
        </p:nvSpPr>
        <p:spPr>
          <a:xfrm>
            <a:off x="4632480" y="5816520"/>
            <a:ext cx="34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e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03T09:53:26Z</dcterms:created>
  <dc:creator>Rebecca Travers</dc:creator>
  <dc:description/>
  <dc:language>en-US</dc:language>
  <cp:lastModifiedBy>ravikumar.n</cp:lastModifiedBy>
  <dcterms:modified xsi:type="dcterms:W3CDTF">2014-12-16T22:38:48Z</dcterms:modified>
  <cp:revision>20</cp:revision>
  <dc:subject/>
  <dc:title>PowerPoint Presentation</dc:title>
</cp:coreProperties>
</file>